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9" r:id="rId3"/>
    <p:sldId id="260" r:id="rId4"/>
    <p:sldId id="262" r:id="rId5"/>
    <p:sldId id="263" r:id="rId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4722"/>
    <p:restoredTop sz="94333"/>
  </p:normalViewPr>
  <p:slideViewPr>
    <p:cSldViewPr snapToGrid="0" snapToObjects="1">
      <p:cViewPr varScale="1">
        <p:scale>
          <a:sx n="103" d="100"/>
          <a:sy n="103" d="100"/>
        </p:scale>
        <p:origin x="138" y="2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665D280-BEAB-5443-AFDA-860F252C3E5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8EBD882C-3E18-7D49-B5EC-93D1A8155B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1E3058B-2FAB-9F48-BA2D-BA39B3A065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0A74D-5DF4-B146-95E4-987F328ACDA0}" type="datetimeFigureOut">
              <a:t>19.08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E80A4C6-D304-0D40-A5B0-03DDE0152F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8FE4C2A-14E9-2448-AE13-0D8091E073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0D07E-A3C5-944D-9038-AF957739226A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40824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FD0EE01-1551-7247-B9A7-EE8B32D803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81AFFAA8-CAC2-CC46-B308-D5C2E726D3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0760672-E733-8047-8901-F589C2A252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0A74D-5DF4-B146-95E4-987F328ACDA0}" type="datetimeFigureOut">
              <a:t>19.08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E2026B2-806B-9242-B1D9-2E859D76DD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8F095C3-6630-CF41-A941-F9C786F92D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0D07E-A3C5-944D-9038-AF957739226A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51254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82F35BF4-4E73-E24C-A470-428F06CFE50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0F06C02A-D99A-3A4F-B987-7AC4F29FAE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2B9A564-6A11-BC42-A5E4-DA771F57C2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0A74D-5DF4-B146-95E4-987F328ACDA0}" type="datetimeFigureOut">
              <a:t>19.08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941933D-C093-C64F-85A9-4D7CA39893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1FDA2E2-6F6B-9D4F-ADD1-799B31C457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0D07E-A3C5-944D-9038-AF957739226A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377283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165EEB8-AFD1-7346-94A5-1A2B7C696F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C0E0A3BF-59C0-724A-A0CF-D08B3F3771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FFEDCD4-AD37-8541-8F58-E622CE6213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0A74D-5DF4-B146-95E4-987F328ACDA0}" type="datetimeFigureOut">
              <a:t>19.08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8ACFAD1-1DB8-6C40-895E-4EA6575261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8DA0418-88C8-4E45-A02B-230DE7268E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0D07E-A3C5-944D-9038-AF957739226A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320490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193FDF9-1053-1241-A6AD-B80ADFF558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0F130FE-0097-E544-9EBA-EAF3D50620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A2B50B4-6C65-5545-9318-80BCD284AF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0A74D-5DF4-B146-95E4-987F328ACDA0}" type="datetimeFigureOut">
              <a:t>19.08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8FB1D58-F042-714F-8D77-9FCD938DB2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F7FBD72-B6E6-2942-B08E-1220C2EB97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0D07E-A3C5-944D-9038-AF957739226A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79267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E53321A-6FC8-EF43-9317-FCFF93B3E6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1F00432-7540-CB4B-BBF9-4212CE7402D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8800AB32-49DD-6C47-8413-F0624452C6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D32F1FD-E150-E54E-9882-128B3E1C8C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0A74D-5DF4-B146-95E4-987F328ACDA0}" type="datetimeFigureOut">
              <a:t>19.08.2020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B9E2957-530B-0140-A2E9-7B00C32CFA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0971441-D377-A54A-BCAB-F838859AE0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0D07E-A3C5-944D-9038-AF957739226A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916340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6B16309-DBB3-C447-A724-3C9BE669BD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BCF91E8-D21A-3649-A062-FC53A03825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DBF5DC1B-72E7-9744-8DE5-AF7EE0F8D2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6E824EAD-CA4D-434F-9E8B-ADEB12293DE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8E056D34-728E-4E4F-ACDC-FB4F8BC4089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4A7D395A-D940-8D42-AC4C-75625C1FC3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0A74D-5DF4-B146-95E4-987F328ACDA0}" type="datetimeFigureOut">
              <a:t>19.08.2020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CE8C9403-0ABE-424B-887A-D46CEB2037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F2D5FDC3-06D6-FC4F-AD87-7AF881977D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0D07E-A3C5-944D-9038-AF957739226A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45784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8E06B28-F6DF-3E4A-BDB7-0EA80C1A62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46DC805E-4CC5-1E4D-91D2-4FB4563B7B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0A74D-5DF4-B146-95E4-987F328ACDA0}" type="datetimeFigureOut">
              <a:t>19.08.2020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784E2BC7-A919-654E-8575-01F127221C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91925E15-48BD-D941-BED5-2530383999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0D07E-A3C5-944D-9038-AF957739226A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923414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2AA3E95B-CE11-2646-8C8D-9D8F2DFD38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0A74D-5DF4-B146-95E4-987F328ACDA0}" type="datetimeFigureOut">
              <a:t>19.08.2020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A814E415-EE36-4F40-8FA9-F4A93A6DB0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D6E1F85B-CACA-EF48-92D3-0FF84B047C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0D07E-A3C5-944D-9038-AF957739226A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7441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5C9A0C6-F2A8-794E-AD97-365EEC4D12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34582FC-A627-7C49-9AFF-4F0AA10160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8AB58583-5F20-DF47-96AC-DB098EF6ED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4C528DC-A926-A744-8B2F-A729DCBD79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0A74D-5DF4-B146-95E4-987F328ACDA0}" type="datetimeFigureOut">
              <a:t>19.08.2020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9EDF60A-9406-D441-A4E4-089F68494A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725BF9B5-834D-CE46-8902-753ECD30BD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0D07E-A3C5-944D-9038-AF957739226A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27784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37AD34F-DAD3-CC41-A42F-E50F14C698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180192B9-249A-7C46-A4BF-CF17CB03813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5681EDA0-E21C-0A4C-BDDC-05FABEE54D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EDEC74E-0640-3947-9713-EBB3D48E4F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0A74D-5DF4-B146-95E4-987F328ACDA0}" type="datetimeFigureOut">
              <a:t>19.08.2020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D8A1D7D-88F7-884C-9822-7A75C3CBD0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1DD2D08-0497-DF45-903D-1A31C97C02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0D07E-A3C5-944D-9038-AF957739226A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38674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EF5089E6-856A-5B4F-AB29-A906CD3F92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E0F809D-2071-894A-BA56-8DF70CB725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4BC9BB1-2E02-0945-A667-044B27773C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50A74D-5DF4-B146-95E4-987F328ACDA0}" type="datetimeFigureOut">
              <a:t>19.08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832E39A-77C8-404F-BB96-D318FC3D7C9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CC8C22B-8F48-2B4B-AD6C-ABE3DBC9D2B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B0D07E-A3C5-944D-9038-AF957739226A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194495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3E6483F3-56F5-8743-B6BF-E93FE1B880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4000" y="1041400"/>
            <a:ext cx="5791200" cy="4775200"/>
          </a:xfrm>
          <a:prstGeom prst="rect">
            <a:avLst/>
          </a:prstGeom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id="{2955087C-06DB-3643-AD0A-299373A7F0F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48500" y="1650114"/>
            <a:ext cx="5143500" cy="3175000"/>
          </a:xfrm>
          <a:prstGeom prst="rect">
            <a:avLst/>
          </a:prstGeom>
        </p:spPr>
      </p:pic>
      <p:sp>
        <p:nvSpPr>
          <p:cNvPr id="6" name="Textfeld 5"/>
          <p:cNvSpPr txBox="1"/>
          <p:nvPr/>
        </p:nvSpPr>
        <p:spPr>
          <a:xfrm>
            <a:off x="1647461" y="5902094"/>
            <a:ext cx="669674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Supplement Figure </a:t>
            </a:r>
            <a:r>
              <a:rPr lang="en-US" sz="1400" b="1" dirty="0" smtClean="0"/>
              <a:t>2 </a:t>
            </a:r>
            <a:r>
              <a:rPr lang="en-US" sz="1400" b="1" dirty="0" smtClean="0"/>
              <a:t>A</a:t>
            </a:r>
            <a:br>
              <a:rPr lang="en-US" sz="1400" b="1" dirty="0" smtClean="0"/>
            </a:br>
            <a:r>
              <a:rPr lang="de-DE" sz="1400" dirty="0"/>
              <a:t>MDS </a:t>
            </a:r>
            <a:r>
              <a:rPr lang="de-DE" sz="1400" dirty="0" err="1"/>
              <a:t>plot</a:t>
            </a:r>
            <a:r>
              <a:rPr lang="de-DE" sz="1400" dirty="0"/>
              <a:t> </a:t>
            </a:r>
            <a:r>
              <a:rPr lang="de-DE" sz="1400" dirty="0" err="1"/>
              <a:t>before</a:t>
            </a:r>
            <a:r>
              <a:rPr lang="de-DE" sz="1400" dirty="0"/>
              <a:t> </a:t>
            </a:r>
            <a:r>
              <a:rPr lang="de-DE" sz="1400" dirty="0" err="1"/>
              <a:t>exclusion</a:t>
            </a:r>
            <a:r>
              <a:rPr lang="de-DE" sz="1400" dirty="0"/>
              <a:t> of m2_postRep, m3_postRep, f1_postRep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28572889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88275675-C4E9-0D48-B1C8-B9881C29DA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55950" y="785297"/>
            <a:ext cx="5880100" cy="4673600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2664498" y="5967908"/>
            <a:ext cx="669674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Supplement Figure </a:t>
            </a:r>
            <a:r>
              <a:rPr lang="en-US" sz="1400" b="1" dirty="0" smtClean="0"/>
              <a:t>2 B</a:t>
            </a:r>
            <a:r>
              <a:rPr lang="en-US" sz="1400" b="1" dirty="0" smtClean="0"/>
              <a:t/>
            </a:r>
            <a:br>
              <a:rPr lang="en-US" sz="1400" b="1" dirty="0" smtClean="0"/>
            </a:br>
            <a:r>
              <a:rPr lang="de-DE" sz="1400" dirty="0"/>
              <a:t>MDS </a:t>
            </a:r>
            <a:r>
              <a:rPr lang="de-DE" sz="1400" dirty="0" err="1"/>
              <a:t>plot</a:t>
            </a:r>
            <a:r>
              <a:rPr lang="de-DE" sz="1400" dirty="0"/>
              <a:t> after </a:t>
            </a:r>
            <a:r>
              <a:rPr lang="de-DE" sz="1400" dirty="0" err="1"/>
              <a:t>exclusion</a:t>
            </a:r>
            <a:r>
              <a:rPr lang="de-DE" sz="1400" dirty="0"/>
              <a:t> of m2_postRep, m3_postRep, f1_postRep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20878863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AFF306B3-64BF-404D-AE7D-CBA439238FE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13050" y="450850"/>
            <a:ext cx="6007100" cy="4737100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2664498" y="5641335"/>
            <a:ext cx="669674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Supplement Figure </a:t>
            </a:r>
            <a:r>
              <a:rPr lang="en-US" sz="1400" b="1" dirty="0" smtClean="0"/>
              <a:t>2 C</a:t>
            </a:r>
            <a:r>
              <a:rPr lang="en-US" sz="1400" b="1" dirty="0" smtClean="0"/>
              <a:t/>
            </a:r>
            <a:br>
              <a:rPr lang="en-US" sz="1400" b="1" dirty="0" smtClean="0"/>
            </a:br>
            <a:r>
              <a:rPr lang="de-DE" sz="1400" dirty="0"/>
              <a:t>MDS </a:t>
            </a:r>
            <a:r>
              <a:rPr lang="de-DE" sz="1400" dirty="0" err="1"/>
              <a:t>plot</a:t>
            </a:r>
            <a:r>
              <a:rPr lang="de-DE" sz="1400" dirty="0"/>
              <a:t> after </a:t>
            </a:r>
            <a:r>
              <a:rPr lang="de-DE" sz="1400" dirty="0" err="1"/>
              <a:t>exclusion</a:t>
            </a:r>
            <a:r>
              <a:rPr lang="de-DE" sz="1400" dirty="0"/>
              <a:t> of m2_postRep, m3_postRep, f1_postRep</a:t>
            </a:r>
          </a:p>
          <a:p>
            <a:r>
              <a:rPr lang="de-DE" sz="1400" dirty="0" err="1"/>
              <a:t>Comparison</a:t>
            </a:r>
            <a:r>
              <a:rPr lang="de-DE" sz="1400" dirty="0"/>
              <a:t> of </a:t>
            </a:r>
            <a:r>
              <a:rPr lang="de-DE" sz="1400" dirty="0" err="1"/>
              <a:t>postRep</a:t>
            </a:r>
            <a:r>
              <a:rPr lang="de-DE" sz="1400" dirty="0"/>
              <a:t> </a:t>
            </a:r>
            <a:r>
              <a:rPr lang="de-DE" sz="1400" dirty="0" err="1"/>
              <a:t>vs</a:t>
            </a:r>
            <a:r>
              <a:rPr lang="de-DE" sz="1400" dirty="0"/>
              <a:t> </a:t>
            </a:r>
            <a:r>
              <a:rPr lang="de-DE" sz="1400" dirty="0" err="1"/>
              <a:t>preCOR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17998268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FB32CA2F-6FD2-394B-8F95-92F62B4C6C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62250" y="660698"/>
            <a:ext cx="5905500" cy="4673600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2869770" y="5697320"/>
            <a:ext cx="753386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Supplement Figure 2 D</a:t>
            </a:r>
            <a:br>
              <a:rPr lang="en-US" sz="1400" b="1" dirty="0" smtClean="0"/>
            </a:br>
            <a:r>
              <a:rPr lang="de-DE" sz="1400" dirty="0"/>
              <a:t>MDS </a:t>
            </a:r>
            <a:r>
              <a:rPr lang="de-DE" sz="1400" dirty="0" err="1"/>
              <a:t>plot</a:t>
            </a:r>
            <a:r>
              <a:rPr lang="de-DE" sz="1400" dirty="0"/>
              <a:t> after </a:t>
            </a:r>
            <a:r>
              <a:rPr lang="de-DE" sz="1400" dirty="0" err="1"/>
              <a:t>exclusion</a:t>
            </a:r>
            <a:r>
              <a:rPr lang="de-DE" sz="1400" dirty="0"/>
              <a:t> of m2_postRep, m3_postRep, f1_postRep</a:t>
            </a:r>
          </a:p>
          <a:p>
            <a:r>
              <a:rPr lang="de-DE" sz="1400" dirty="0" err="1"/>
              <a:t>Comparison</a:t>
            </a:r>
            <a:r>
              <a:rPr lang="de-DE" sz="1400" dirty="0"/>
              <a:t> of </a:t>
            </a:r>
            <a:r>
              <a:rPr lang="de-DE" sz="1400" dirty="0" err="1"/>
              <a:t>postRep</a:t>
            </a:r>
            <a:r>
              <a:rPr lang="de-DE" sz="1400" dirty="0"/>
              <a:t> </a:t>
            </a:r>
            <a:r>
              <a:rPr lang="de-DE" sz="1400" dirty="0" err="1"/>
              <a:t>vs</a:t>
            </a:r>
            <a:r>
              <a:rPr lang="de-DE" sz="1400" dirty="0"/>
              <a:t> </a:t>
            </a:r>
            <a:r>
              <a:rPr lang="de-DE" sz="1400" dirty="0" err="1"/>
              <a:t>postCOR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3314338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C0FA4C8A-FEF7-2141-9C05-34FA36BFBD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41650" y="374650"/>
            <a:ext cx="6108700" cy="4838700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2664498" y="5790625"/>
            <a:ext cx="669674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Supplement Figure </a:t>
            </a:r>
            <a:r>
              <a:rPr lang="en-US" sz="1400" b="1" dirty="0" smtClean="0"/>
              <a:t>2 E</a:t>
            </a:r>
            <a:r>
              <a:rPr lang="en-US" sz="1400" b="1" dirty="0" smtClean="0"/>
              <a:t/>
            </a:r>
            <a:br>
              <a:rPr lang="en-US" sz="1400" b="1" dirty="0" smtClean="0"/>
            </a:br>
            <a:r>
              <a:rPr lang="de-DE" sz="1400" dirty="0"/>
              <a:t>MDS </a:t>
            </a:r>
            <a:r>
              <a:rPr lang="de-DE" sz="1400" dirty="0" err="1"/>
              <a:t>plot</a:t>
            </a:r>
            <a:r>
              <a:rPr lang="de-DE" sz="1400" dirty="0"/>
              <a:t> after </a:t>
            </a:r>
            <a:r>
              <a:rPr lang="de-DE" sz="1400" dirty="0" err="1"/>
              <a:t>exclusion</a:t>
            </a:r>
            <a:r>
              <a:rPr lang="de-DE" sz="1400" dirty="0"/>
              <a:t> of m2_postRep, m3_postRep, f1_postRep</a:t>
            </a:r>
          </a:p>
          <a:p>
            <a:r>
              <a:rPr lang="de-DE" sz="1400" dirty="0" err="1"/>
              <a:t>Comparison</a:t>
            </a:r>
            <a:r>
              <a:rPr lang="de-DE" sz="1400" dirty="0"/>
              <a:t> of </a:t>
            </a:r>
            <a:r>
              <a:rPr lang="de-DE" sz="1400" dirty="0" err="1"/>
              <a:t>postCOR</a:t>
            </a:r>
            <a:r>
              <a:rPr lang="de-DE" sz="1400" dirty="0"/>
              <a:t> </a:t>
            </a:r>
            <a:r>
              <a:rPr lang="de-DE" sz="1400" dirty="0" err="1"/>
              <a:t>vs</a:t>
            </a:r>
            <a:r>
              <a:rPr lang="de-DE" sz="1400" dirty="0"/>
              <a:t> </a:t>
            </a:r>
            <a:r>
              <a:rPr lang="de-DE" sz="1400" dirty="0" err="1"/>
              <a:t>preCOR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18315910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0</Words>
  <Application>Microsoft Office PowerPoint</Application>
  <PresentationFormat>Breitbild</PresentationFormat>
  <Paragraphs>8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ahal BA</dc:creator>
  <cp:lastModifiedBy>Dr. med.Hoyer, Dieter Paul</cp:lastModifiedBy>
  <cp:revision>17</cp:revision>
  <dcterms:created xsi:type="dcterms:W3CDTF">2020-07-21T12:42:36Z</dcterms:created>
  <dcterms:modified xsi:type="dcterms:W3CDTF">2020-08-19T13:41:25Z</dcterms:modified>
</cp:coreProperties>
</file>